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-2766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7125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6451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276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1666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7031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7581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4070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362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7167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755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1439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B879D-DF57-475D-AEFD-8EB17C826EB6}" type="datetimeFigureOut">
              <a:rPr lang="en-GB" smtClean="0"/>
              <a:t>23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57932-CC50-4532-98DE-2AAF12E48D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844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33573" y="1640144"/>
            <a:ext cx="2659111" cy="1438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51333" y="2052716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6" name="Picture 3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99440" y="1198349"/>
            <a:ext cx="187200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33573" y="3734422"/>
            <a:ext cx="2656731" cy="139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6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699440" y="3278522"/>
            <a:ext cx="187200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633573" y="5956818"/>
            <a:ext cx="2656733" cy="14506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-94618" y="4151981"/>
            <a:ext cx="1514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mM VPA</a:t>
            </a:r>
            <a:endParaRPr lang="en-GB" sz="1200" b="1" dirty="0" smtClean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310643" y="6384229"/>
            <a:ext cx="1730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µM</a:t>
            </a:r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UNC1999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2" name="Picture 9"/>
          <p:cNvPicPr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699440" y="5526739"/>
            <a:ext cx="187200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11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633573" y="8203394"/>
            <a:ext cx="2669651" cy="14291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>
            <a:off x="193413" y="8563141"/>
            <a:ext cx="1226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mM VPA </a:t>
            </a:r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 </a:t>
            </a:r>
            <a:r>
              <a:rPr lang="en-GB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µM UNC1999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5" name="Picture 12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699440" y="7778732"/>
            <a:ext cx="187200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>
            <a:off x="4881325" y="1319607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9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906869" y="1288323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9.3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881325" y="2296435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85.1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906869" y="2296435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4.8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881325" y="332245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.1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906869" y="331358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1.5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881325" y="4298431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83.9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906869" y="4298431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.6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881325" y="5657217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.1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906869" y="5625933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0.9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854430" y="6634045"/>
            <a:ext cx="7810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83.13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906869" y="6634045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4.9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81325" y="7876779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.1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906869" y="7845495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2.5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881325" y="8853607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81.0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906869" y="8853607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5.4%</a:t>
            </a:r>
            <a:endParaRPr lang="en-GB" sz="11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569677" y="2927845"/>
            <a:ext cx="13340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569677" y="5016077"/>
            <a:ext cx="13340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569677" y="7248325"/>
            <a:ext cx="13340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569677" y="9480573"/>
            <a:ext cx="13340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364877" y="2033381"/>
            <a:ext cx="67037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unts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1364877" y="4171316"/>
            <a:ext cx="67037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unts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1364877" y="6403564"/>
            <a:ext cx="67037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unts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1364877" y="8580574"/>
            <a:ext cx="67037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unts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052081" y="2927845"/>
            <a:ext cx="12442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052081" y="5016077"/>
            <a:ext cx="12442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052081" y="7248325"/>
            <a:ext cx="12442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052081" y="9480573"/>
            <a:ext cx="12442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pidium</a:t>
            </a:r>
            <a:r>
              <a:rPr lang="en-GB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odide</a:t>
            </a:r>
            <a:endParaRPr lang="en-GB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4203864" y="1897076"/>
            <a:ext cx="88357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nexin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V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4203864" y="3995528"/>
            <a:ext cx="88357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nexin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V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4203864" y="6211411"/>
            <a:ext cx="88357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nexin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V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4203864" y="8481250"/>
            <a:ext cx="88357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nexin</a:t>
            </a:r>
            <a:r>
              <a:rPr lang="en-GB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V</a:t>
            </a:r>
            <a:endParaRPr lang="en-GB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4364" y="100729"/>
            <a:ext cx="67394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Data File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- The effect of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1999 and VPA on LCL viability</a:t>
            </a:r>
          </a:p>
          <a:p>
            <a:pPr algn="just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H LCL cells were treated with 1mM VPA, 3µM UNC1999 or the two in combination for 24 hours. Cell cycle profile was assessed by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pidiu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odide staining and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otosis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y the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V assay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2402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22</Words>
  <Application>Microsoft Office PowerPoint</Application>
  <PresentationFormat>A4 Paper (210x297 mm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Halsall</dc:creator>
  <cp:lastModifiedBy>John Halsall</cp:lastModifiedBy>
  <cp:revision>3</cp:revision>
  <dcterms:created xsi:type="dcterms:W3CDTF">2015-07-23T12:55:55Z</dcterms:created>
  <dcterms:modified xsi:type="dcterms:W3CDTF">2015-07-23T13:48:52Z</dcterms:modified>
</cp:coreProperties>
</file>